
<file path=[Content_Types].xml><?xml version="1.0" encoding="utf-8"?>
<Types xmlns="http://schemas.openxmlformats.org/package/2006/content-types"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5"/>
  </p:notesMasterIdLst>
  <p:sldIdLst>
    <p:sldId id="256" r:id="rId2"/>
    <p:sldId id="257" r:id="rId3"/>
    <p:sldId id="258" r:id="rId4"/>
  </p:sldIdLst>
  <p:sldSz cx="12192000" cy="68580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GoogleSlidesCustomDataVersion2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8" roundtripDataSignature="AMtx7mi3BdTu0zEe9rpNp6+SDCFZLasO9w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5" d="100"/>
          <a:sy n="75" d="100"/>
        </p:scale>
        <p:origin x="874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customschemas.google.com/relationships/presentationmetadata" Target="metadata"/><Relationship Id="rId3" Type="http://schemas.openxmlformats.org/officeDocument/2006/relationships/slide" Target="slides/slide2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11" Type="http://schemas.openxmlformats.org/officeDocument/2006/relationships/theme" Target="theme/theme1.xml"/><Relationship Id="rId5" Type="http://schemas.openxmlformats.org/officeDocument/2006/relationships/notesMaster" Target="notesMasters/notesMaster1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2" name="Google Shape;82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Google Shape;93;p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94" name="Google Shape;94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0" name="Google Shape;120;p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21" name="Google Shape;121;p3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4" name="Google Shape;14;p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A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4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4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A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5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5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A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6"/>
          <p:cNvSpPr txBox="1"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6"/>
          <p:cNvSpPr txBox="1"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18" name="Google Shape;18;p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0" name="Google Shape;20;p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A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7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7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4" name="Google Shape;24;p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A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8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8"/>
          <p:cNvSpPr txBox="1"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A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9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9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9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A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10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10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3" name="Google Shape;43;p10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10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5" name="Google Shape;45;p10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1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1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A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11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1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A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2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2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57" name="Google Shape;57;p12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58" name="Google Shape;58;p1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A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3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3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3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5" name="Google Shape;65;p1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AU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4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4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AU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jpg"/><Relationship Id="rId5" Type="http://schemas.openxmlformats.org/officeDocument/2006/relationships/image" Target="../media/image5.jpg"/><Relationship Id="rId4" Type="http://schemas.openxmlformats.org/officeDocument/2006/relationships/image" Target="../media/image4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BC6689DD-006B-6842-8570-A475C816AC80}"/>
              </a:ext>
            </a:extLst>
          </p:cNvPr>
          <p:cNvGrpSpPr/>
          <p:nvPr/>
        </p:nvGrpSpPr>
        <p:grpSpPr>
          <a:xfrm>
            <a:off x="908424" y="1041606"/>
            <a:ext cx="7987552" cy="4406510"/>
            <a:chOff x="908424" y="1041606"/>
            <a:chExt cx="7987552" cy="4406510"/>
          </a:xfrm>
        </p:grpSpPr>
        <p:grpSp>
          <p:nvGrpSpPr>
            <p:cNvPr id="84" name="Google Shape;84;p1"/>
            <p:cNvGrpSpPr/>
            <p:nvPr/>
          </p:nvGrpSpPr>
          <p:grpSpPr>
            <a:xfrm>
              <a:off x="1007573" y="1041606"/>
              <a:ext cx="5092002" cy="3209473"/>
              <a:chOff x="1330303" y="611301"/>
              <a:chExt cx="5092002" cy="3209473"/>
            </a:xfrm>
          </p:grpSpPr>
          <p:sp>
            <p:nvSpPr>
              <p:cNvPr id="87" name="Google Shape;87;p1"/>
              <p:cNvSpPr txBox="1"/>
              <p:nvPr/>
            </p:nvSpPr>
            <p:spPr>
              <a:xfrm>
                <a:off x="6138911" y="611301"/>
                <a:ext cx="283394" cy="3693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AU" sz="1800" b="0" i="0" u="none" strike="noStrike" cap="non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B</a:t>
                </a:r>
                <a:endParaRPr sz="18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  <p:grpSp>
            <p:nvGrpSpPr>
              <p:cNvPr id="88" name="Google Shape;88;p1"/>
              <p:cNvGrpSpPr/>
              <p:nvPr/>
            </p:nvGrpSpPr>
            <p:grpSpPr>
              <a:xfrm>
                <a:off x="1330303" y="611301"/>
                <a:ext cx="4765697" cy="3209473"/>
                <a:chOff x="2863268" y="683984"/>
                <a:chExt cx="4765697" cy="3209473"/>
              </a:xfrm>
            </p:grpSpPr>
            <p:pic>
              <p:nvPicPr>
                <p:cNvPr id="89" name="Google Shape;89;p1"/>
                <p:cNvPicPr preferRelativeResize="0"/>
                <p:nvPr/>
              </p:nvPicPr>
              <p:blipFill rotWithShape="1">
                <a:blip r:embed="rId3">
                  <a:alphaModFix/>
                </a:blip>
                <a:srcRect/>
                <a:stretch/>
              </p:blipFill>
              <p:spPr>
                <a:xfrm>
                  <a:off x="2863268" y="683984"/>
                  <a:ext cx="4765697" cy="3209473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  <p:sp>
              <p:nvSpPr>
                <p:cNvPr id="90" name="Google Shape;90;p1"/>
                <p:cNvSpPr txBox="1"/>
                <p:nvPr/>
              </p:nvSpPr>
              <p:spPr>
                <a:xfrm>
                  <a:off x="2863268" y="683984"/>
                  <a:ext cx="283394" cy="369332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spAutoFit/>
                </a:bodyPr>
                <a:lstStyle/>
                <a:p>
                  <a:pPr marL="0" marR="0" lvl="0" indent="0" algn="l" rtl="0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lang="en-AU" sz="1800">
                      <a:solidFill>
                        <a:srgbClr val="F2F2F2"/>
                      </a:solidFill>
                      <a:latin typeface="Calibri"/>
                      <a:ea typeface="Calibri"/>
                      <a:cs typeface="Calibri"/>
                      <a:sym typeface="Calibri"/>
                    </a:rPr>
                    <a:t>A</a:t>
                  </a:r>
                  <a:endParaRPr sz="1800">
                    <a:solidFill>
                      <a:srgbClr val="F2F2F2"/>
                    </a:solidFill>
                    <a:latin typeface="Calibri"/>
                    <a:ea typeface="Calibri"/>
                    <a:cs typeface="Calibri"/>
                    <a:sym typeface="Calibri"/>
                  </a:endParaRPr>
                </a:p>
              </p:txBody>
            </p:sp>
          </p:grpSp>
        </p:grpSp>
        <p:sp>
          <p:nvSpPr>
            <p:cNvPr id="91" name="Google Shape;91;p1"/>
            <p:cNvSpPr txBox="1"/>
            <p:nvPr/>
          </p:nvSpPr>
          <p:spPr>
            <a:xfrm>
              <a:off x="908424" y="4524786"/>
              <a:ext cx="7987552" cy="92333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AU" sz="1800" b="1" dirty="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Figure S1: </a:t>
              </a:r>
              <a:r>
                <a:rPr lang="en-AU" sz="1800" dirty="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Contact angle of the PVA-coated PDMS. A) The different contact angles (CA) of PDMS surfaces after the selective PVA coating process. B) the box plot shows the measured CA of the PVA-coated regions (</a:t>
              </a:r>
              <a:r>
                <a:rPr lang="en-AU" sz="1800" i="1" dirty="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n</a:t>
              </a:r>
              <a:r>
                <a:rPr lang="en-AU" sz="1800" dirty="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=9).</a:t>
              </a:r>
              <a:endParaRPr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B044506D-D7E0-4E76-217C-AE0134811BF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773270" y="1041606"/>
              <a:ext cx="2792210" cy="3225064"/>
            </a:xfrm>
            <a:prstGeom prst="rect">
              <a:avLst/>
            </a:prstGeom>
          </p:spPr>
        </p:pic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Google Shape;96;p2"/>
          <p:cNvSpPr txBox="1"/>
          <p:nvPr/>
        </p:nvSpPr>
        <p:spPr>
          <a:xfrm>
            <a:off x="299087" y="140250"/>
            <a:ext cx="4221805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AU"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ry documents</a:t>
            </a:r>
            <a:endParaRPr/>
          </a:p>
        </p:txBody>
      </p:sp>
      <p:sp>
        <p:nvSpPr>
          <p:cNvPr id="97" name="Google Shape;97;p2"/>
          <p:cNvSpPr txBox="1"/>
          <p:nvPr/>
        </p:nvSpPr>
        <p:spPr>
          <a:xfrm>
            <a:off x="299087" y="594829"/>
            <a:ext cx="5612860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AU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oncave up  and down position</a:t>
            </a:r>
            <a:endParaRPr/>
          </a:p>
        </p:txBody>
      </p:sp>
      <p:grpSp>
        <p:nvGrpSpPr>
          <p:cNvPr id="98" name="Google Shape;98;p2"/>
          <p:cNvGrpSpPr/>
          <p:nvPr/>
        </p:nvGrpSpPr>
        <p:grpSpPr>
          <a:xfrm>
            <a:off x="860612" y="1001701"/>
            <a:ext cx="9234364" cy="5490226"/>
            <a:chOff x="787460" y="1053902"/>
            <a:chExt cx="9234364" cy="5490226"/>
          </a:xfrm>
        </p:grpSpPr>
        <p:grpSp>
          <p:nvGrpSpPr>
            <p:cNvPr id="99" name="Google Shape;99;p2"/>
            <p:cNvGrpSpPr/>
            <p:nvPr/>
          </p:nvGrpSpPr>
          <p:grpSpPr>
            <a:xfrm>
              <a:off x="787460" y="1053902"/>
              <a:ext cx="9234364" cy="5490226"/>
              <a:chOff x="348548" y="1309934"/>
              <a:chExt cx="9234364" cy="5490226"/>
            </a:xfrm>
          </p:grpSpPr>
          <p:grpSp>
            <p:nvGrpSpPr>
              <p:cNvPr id="100" name="Google Shape;100;p2"/>
              <p:cNvGrpSpPr/>
              <p:nvPr/>
            </p:nvGrpSpPr>
            <p:grpSpPr>
              <a:xfrm>
                <a:off x="5991729" y="1354238"/>
                <a:ext cx="3270298" cy="4543562"/>
                <a:chOff x="2123817" y="1236733"/>
                <a:chExt cx="3270298" cy="4543562"/>
              </a:xfrm>
            </p:grpSpPr>
            <p:pic>
              <p:nvPicPr>
                <p:cNvPr id="101" name="Google Shape;101;p2" descr="A red and white circle with white lines&#10;&#10;Description automatically generated with medium confidence"/>
                <p:cNvPicPr preferRelativeResize="0"/>
                <p:nvPr/>
              </p:nvPicPr>
              <p:blipFill rotWithShape="1">
                <a:blip r:embed="rId3">
                  <a:alphaModFix/>
                </a:blip>
                <a:srcRect t="4795" r="3954" b="4396"/>
                <a:stretch/>
              </p:blipFill>
              <p:spPr>
                <a:xfrm rot="-5400000">
                  <a:off x="2783876" y="3179198"/>
                  <a:ext cx="1941038" cy="3261156"/>
                </a:xfrm>
                <a:prstGeom prst="rect">
                  <a:avLst/>
                </a:prstGeom>
                <a:noFill/>
                <a:ln w="9525" cap="flat" cmpd="sng">
                  <a:solidFill>
                    <a:schemeClr val="dk1"/>
                  </a:solidFill>
                  <a:prstDash val="solid"/>
                  <a:round/>
                  <a:headEnd type="none" w="sm" len="sm"/>
                  <a:tailEnd type="none" w="sm" len="sm"/>
                </a:ln>
              </p:spPr>
            </p:pic>
            <p:pic>
              <p:nvPicPr>
                <p:cNvPr id="102" name="Google Shape;102;p2" descr="A close-up of an orange ball&#10;&#10;Description automatically generated"/>
                <p:cNvPicPr preferRelativeResize="0"/>
                <p:nvPr/>
              </p:nvPicPr>
              <p:blipFill rotWithShape="1">
                <a:blip r:embed="rId4">
                  <a:alphaModFix/>
                </a:blip>
                <a:srcRect l="7796" t="6332" r="4789" b="11395"/>
                <a:stretch/>
              </p:blipFill>
              <p:spPr>
                <a:xfrm rot="-5400000">
                  <a:off x="2789451" y="1052609"/>
                  <a:ext cx="1948174" cy="3261153"/>
                </a:xfrm>
                <a:prstGeom prst="rect">
                  <a:avLst/>
                </a:prstGeom>
                <a:noFill/>
                <a:ln w="9525" cap="flat" cmpd="sng">
                  <a:solidFill>
                    <a:schemeClr val="dk1"/>
                  </a:solidFill>
                  <a:prstDash val="solid"/>
                  <a:round/>
                  <a:headEnd type="none" w="sm" len="sm"/>
                  <a:tailEnd type="none" w="sm" len="sm"/>
                </a:ln>
              </p:spPr>
            </p:pic>
            <p:sp>
              <p:nvSpPr>
                <p:cNvPr id="103" name="Google Shape;103;p2"/>
                <p:cNvSpPr txBox="1"/>
                <p:nvPr/>
              </p:nvSpPr>
              <p:spPr>
                <a:xfrm>
                  <a:off x="2855780" y="1236733"/>
                  <a:ext cx="2529191" cy="400110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spAutoFit/>
                </a:bodyPr>
                <a:lstStyle/>
                <a:p>
                  <a:pPr marL="0" marR="0" lvl="0" indent="0" algn="l" rtl="0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lang="en-AU" sz="2000" b="1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rPr>
                    <a:t>Concave - down</a:t>
                  </a:r>
                  <a:endParaRPr/>
                </a:p>
              </p:txBody>
            </p:sp>
          </p:grpSp>
          <p:grpSp>
            <p:nvGrpSpPr>
              <p:cNvPr id="104" name="Google Shape;104;p2"/>
              <p:cNvGrpSpPr/>
              <p:nvPr/>
            </p:nvGrpSpPr>
            <p:grpSpPr>
              <a:xfrm>
                <a:off x="2071024" y="1347245"/>
                <a:ext cx="3676070" cy="4550556"/>
                <a:chOff x="5534636" y="1302892"/>
                <a:chExt cx="3676070" cy="4550556"/>
              </a:xfrm>
            </p:grpSpPr>
            <p:pic>
              <p:nvPicPr>
                <p:cNvPr id="105" name="Google Shape;105;p2" descr="A picture containing text, container, plastic&#10;&#10;Description automatically generated"/>
                <p:cNvPicPr preferRelativeResize="0"/>
                <p:nvPr/>
              </p:nvPicPr>
              <p:blipFill rotWithShape="1">
                <a:blip r:embed="rId5">
                  <a:alphaModFix/>
                </a:blip>
                <a:srcRect t="2426" r="6511"/>
                <a:stretch/>
              </p:blipFill>
              <p:spPr>
                <a:xfrm rot="5400000">
                  <a:off x="6366254" y="3074624"/>
                  <a:ext cx="1947205" cy="3610442"/>
                </a:xfrm>
                <a:prstGeom prst="rect">
                  <a:avLst/>
                </a:prstGeom>
                <a:noFill/>
                <a:ln w="9525" cap="flat" cmpd="sng">
                  <a:solidFill>
                    <a:schemeClr val="dk1"/>
                  </a:solidFill>
                  <a:prstDash val="solid"/>
                  <a:round/>
                  <a:headEnd type="none" w="sm" len="sm"/>
                  <a:tailEnd type="none" w="sm" len="sm"/>
                </a:ln>
              </p:spPr>
            </p:pic>
            <p:pic>
              <p:nvPicPr>
                <p:cNvPr id="106" name="Google Shape;106;p2" descr="A picture containing bell jar&#10;&#10;Description automatically generated"/>
                <p:cNvPicPr preferRelativeResize="0"/>
                <p:nvPr/>
              </p:nvPicPr>
              <p:blipFill rotWithShape="1">
                <a:blip r:embed="rId6">
                  <a:alphaModFix/>
                </a:blip>
                <a:srcRect l="14080" t="10980" r="7803" b="7582"/>
                <a:stretch/>
              </p:blipFill>
              <p:spPr>
                <a:xfrm rot="5400000">
                  <a:off x="6366256" y="932344"/>
                  <a:ext cx="1947205" cy="3610443"/>
                </a:xfrm>
                <a:prstGeom prst="rect">
                  <a:avLst/>
                </a:prstGeom>
                <a:noFill/>
                <a:ln w="9525" cap="flat" cmpd="sng">
                  <a:solidFill>
                    <a:schemeClr val="dk1"/>
                  </a:solidFill>
                  <a:prstDash val="solid"/>
                  <a:round/>
                  <a:headEnd type="none" w="sm" len="sm"/>
                  <a:tailEnd type="none" w="sm" len="sm"/>
                </a:ln>
              </p:spPr>
            </p:pic>
            <p:sp>
              <p:nvSpPr>
                <p:cNvPr id="107" name="Google Shape;107;p2"/>
                <p:cNvSpPr txBox="1"/>
                <p:nvPr/>
              </p:nvSpPr>
              <p:spPr>
                <a:xfrm>
                  <a:off x="6681514" y="1302892"/>
                  <a:ext cx="2529191" cy="400110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spAutoFit/>
                </a:bodyPr>
                <a:lstStyle/>
                <a:p>
                  <a:pPr marL="0" marR="0" lvl="0" indent="0" algn="l" rtl="0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lang="en-AU" sz="2000" b="1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rPr>
                    <a:t>Concave - up</a:t>
                  </a:r>
                  <a:endParaRPr/>
                </a:p>
              </p:txBody>
            </p:sp>
          </p:grpSp>
          <p:sp>
            <p:nvSpPr>
              <p:cNvPr id="108" name="Google Shape;108;p2"/>
              <p:cNvSpPr txBox="1"/>
              <p:nvPr/>
            </p:nvSpPr>
            <p:spPr>
              <a:xfrm>
                <a:off x="348548" y="6153829"/>
                <a:ext cx="9234364" cy="64633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AU" sz="1800" b="1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Figure S2</a:t>
                </a:r>
                <a:r>
                  <a:rPr lang="en-AU" sz="1800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: The </a:t>
                </a:r>
                <a:r>
                  <a:rPr lang="en-AU" sz="1800" i="1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Concave-up </a:t>
                </a:r>
                <a:r>
                  <a:rPr lang="en-AU" sz="1800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chamber was before (A1) and after heating (A2); the </a:t>
                </a:r>
                <a:r>
                  <a:rPr lang="en-AU" sz="1800" i="1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Concave-down </a:t>
                </a:r>
                <a:r>
                  <a:rPr lang="en-AU" sz="1800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chamber was before (B1) and after heating (B2). The heating condition was 70℃ for 25 minutes.</a:t>
                </a:r>
                <a:endParaRPr sz="18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109" name="Google Shape;109;p2"/>
              <p:cNvSpPr txBox="1"/>
              <p:nvPr/>
            </p:nvSpPr>
            <p:spPr>
              <a:xfrm>
                <a:off x="667512" y="2396059"/>
                <a:ext cx="1230414" cy="64633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AU" sz="1800" b="1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Before heating</a:t>
                </a:r>
                <a:endParaRPr/>
              </a:p>
            </p:txBody>
          </p:sp>
          <p:sp>
            <p:nvSpPr>
              <p:cNvPr id="110" name="Google Shape;110;p2"/>
              <p:cNvSpPr txBox="1"/>
              <p:nvPr/>
            </p:nvSpPr>
            <p:spPr>
              <a:xfrm>
                <a:off x="667512" y="4461941"/>
                <a:ext cx="1230414" cy="64633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AU" sz="1800" b="1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After heating</a:t>
                </a:r>
                <a:endParaRPr/>
              </a:p>
            </p:txBody>
          </p:sp>
          <p:sp>
            <p:nvSpPr>
              <p:cNvPr id="111" name="Google Shape;111;p2"/>
              <p:cNvSpPr/>
              <p:nvPr/>
            </p:nvSpPr>
            <p:spPr>
              <a:xfrm>
                <a:off x="1897926" y="1309934"/>
                <a:ext cx="3926801" cy="4710064"/>
              </a:xfrm>
              <a:prstGeom prst="rect">
                <a:avLst/>
              </a:prstGeom>
              <a:noFill/>
              <a:ln w="12700" cap="flat" cmpd="sng">
                <a:solidFill>
                  <a:srgbClr val="0C0C0C"/>
                </a:solidFill>
                <a:prstDash val="dash"/>
                <a:miter lim="800000"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112" name="Google Shape;112;p2"/>
              <p:cNvSpPr/>
              <p:nvPr/>
            </p:nvSpPr>
            <p:spPr>
              <a:xfrm>
                <a:off x="5824728" y="1309934"/>
                <a:ext cx="3593592" cy="4710064"/>
              </a:xfrm>
              <a:prstGeom prst="rect">
                <a:avLst/>
              </a:prstGeom>
              <a:noFill/>
              <a:ln w="12700" cap="flat" cmpd="sng">
                <a:solidFill>
                  <a:srgbClr val="0C0C0C"/>
                </a:solidFill>
                <a:prstDash val="dash"/>
                <a:miter lim="800000"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113" name="Google Shape;113;p2"/>
              <p:cNvSpPr/>
              <p:nvPr/>
            </p:nvSpPr>
            <p:spPr>
              <a:xfrm>
                <a:off x="950976" y="1754347"/>
                <a:ext cx="8467343" cy="2098237"/>
              </a:xfrm>
              <a:prstGeom prst="rect">
                <a:avLst/>
              </a:prstGeom>
              <a:noFill/>
              <a:ln w="12700" cap="flat" cmpd="sng">
                <a:solidFill>
                  <a:srgbClr val="0C0C0C"/>
                </a:solidFill>
                <a:prstDash val="dash"/>
                <a:miter lim="800000"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114" name="Google Shape;114;p2"/>
              <p:cNvSpPr/>
              <p:nvPr/>
            </p:nvSpPr>
            <p:spPr>
              <a:xfrm>
                <a:off x="950976" y="3847034"/>
                <a:ext cx="8467343" cy="2172964"/>
              </a:xfrm>
              <a:prstGeom prst="rect">
                <a:avLst/>
              </a:prstGeom>
              <a:noFill/>
              <a:ln w="12700" cap="flat" cmpd="sng">
                <a:solidFill>
                  <a:srgbClr val="0C0C0C"/>
                </a:solidFill>
                <a:prstDash val="dash"/>
                <a:miter lim="800000"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</p:grpSp>
        <p:sp>
          <p:nvSpPr>
            <p:cNvPr id="115" name="Google Shape;115;p2"/>
            <p:cNvSpPr txBox="1"/>
            <p:nvPr/>
          </p:nvSpPr>
          <p:spPr>
            <a:xfrm>
              <a:off x="2509936" y="1523167"/>
              <a:ext cx="694944" cy="36933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AU" sz="1800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A1</a:t>
              </a:r>
              <a:endParaRPr/>
            </a:p>
          </p:txBody>
        </p:sp>
        <p:sp>
          <p:nvSpPr>
            <p:cNvPr id="116" name="Google Shape;116;p2"/>
            <p:cNvSpPr txBox="1"/>
            <p:nvPr/>
          </p:nvSpPr>
          <p:spPr>
            <a:xfrm>
              <a:off x="2509936" y="3716564"/>
              <a:ext cx="694944" cy="36933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AU" sz="1800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A2</a:t>
              </a:r>
              <a:endParaRPr/>
            </a:p>
          </p:txBody>
        </p:sp>
        <p:sp>
          <p:nvSpPr>
            <p:cNvPr id="117" name="Google Shape;117;p2"/>
            <p:cNvSpPr txBox="1"/>
            <p:nvPr/>
          </p:nvSpPr>
          <p:spPr>
            <a:xfrm>
              <a:off x="6499128" y="1564901"/>
              <a:ext cx="694944" cy="36933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AU" sz="1800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B1</a:t>
              </a:r>
              <a:endParaRPr/>
            </a:p>
          </p:txBody>
        </p:sp>
        <p:sp>
          <p:nvSpPr>
            <p:cNvPr id="118" name="Google Shape;118;p2"/>
            <p:cNvSpPr txBox="1"/>
            <p:nvPr/>
          </p:nvSpPr>
          <p:spPr>
            <a:xfrm>
              <a:off x="6499128" y="3758298"/>
              <a:ext cx="694944" cy="36933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AU" sz="1800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B2</a:t>
              </a:r>
              <a:endParaRPr/>
            </a:p>
          </p:txBody>
        </p: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2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Google Shape;123;p3"/>
          <p:cNvSpPr txBox="1"/>
          <p:nvPr/>
        </p:nvSpPr>
        <p:spPr>
          <a:xfrm>
            <a:off x="294356" y="91310"/>
            <a:ext cx="10956300" cy="6465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AU" sz="18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igure S3: </a:t>
            </a:r>
            <a:r>
              <a:rPr lang="en-AU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LAMP-on chip reactions after stored at -20</a:t>
            </a:r>
            <a:r>
              <a:rPr lang="en-AU" sz="18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℃ for</a:t>
            </a:r>
            <a:r>
              <a:rPr lang="en-AU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(A) 1 day; and (B) for 3 days. No template control (NCT) was blank/water and positive sample was 5000 copies/µl of cDNA N-gene SARS-CoV-2. </a:t>
            </a:r>
            <a:endParaRPr dirty="0"/>
          </a:p>
        </p:txBody>
      </p:sp>
      <p:pic>
        <p:nvPicPr>
          <p:cNvPr id="124" name="Google Shape;124;p3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1134981" y="1043914"/>
            <a:ext cx="9102713" cy="5330816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1</Words>
  <Application>Microsoft Office PowerPoint</Application>
  <PresentationFormat>Widescreen</PresentationFormat>
  <Paragraphs>15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Xuan Le</dc:creator>
  <cp:lastModifiedBy>Xuan Le</cp:lastModifiedBy>
  <cp:revision>1</cp:revision>
  <dcterms:created xsi:type="dcterms:W3CDTF">2024-01-30T02:06:42Z</dcterms:created>
  <dcterms:modified xsi:type="dcterms:W3CDTF">2024-08-23T05:44:35Z</dcterms:modified>
</cp:coreProperties>
</file>